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6870DE-9FFA-4156-A58E-EDBA955037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1BB0C-3ABA-4326-BFAF-AC0CF94210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52A9D5-1431-42A0-8867-22EFE572E4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21FB59-66C6-46F9-A90D-1E915D3913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A29DE1-7BCC-4224-83D3-91F83C4926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6B06E9-B609-452C-A260-DF71D3FA89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82FD1-6181-4880-BF28-BEEBE154BB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FACB2-B466-4457-BCA1-7F38D1966F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6AD7E-B511-45F6-84D3-B080E978DD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5E8D6-9845-4DB1-9977-3759CE449D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F8078F-CAF9-46EE-9E7B-FB87F09EBB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173076-7144-4A4B-B25A-F46BE812FC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8C2FCB-3D87-4E48-A1EA-2DD2B3BF080C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2573280" y="5391000"/>
            <a:ext cx="6121440" cy="10782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l Figure 2.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A scatter plot and regression graph depicting daily diastolic blood pressure measurements following a 12-week intervention period in CON (a) (n=7), EXR (b) (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n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=7), BRJ (c) (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n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=8), EXR &amp; BRJ (d) (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n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=7) groups. Linear regression lines, correlation coefficient (r), and P-value (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)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 are displayed in the above graphs. P-value and correlation coefficient were calculated via one-tailed Pearson’s correlation coefficient. Significance is defined as P&lt;0.05. Abbreviations: EXR, Exercise; BRJ, Beetroot Juice; CON, Control; DBP, Diastolic Blood Pressure.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Object 4"/>
          <p:cNvGraphicFramePr/>
          <p:nvPr/>
        </p:nvGraphicFramePr>
        <p:xfrm>
          <a:off x="2144880" y="2936880"/>
          <a:ext cx="3686040" cy="2454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144880" y="2936880"/>
                    <a:ext cx="3686040" cy="2454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4" name="Object 5"/>
          <p:cNvGraphicFramePr/>
          <p:nvPr/>
        </p:nvGraphicFramePr>
        <p:xfrm>
          <a:off x="2149560" y="633240"/>
          <a:ext cx="3686040" cy="24544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5" name="Object 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149560" y="633240"/>
                    <a:ext cx="3686040" cy="2454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6" name="Object 6"/>
          <p:cNvGraphicFramePr/>
          <p:nvPr/>
        </p:nvGraphicFramePr>
        <p:xfrm>
          <a:off x="5634000" y="633240"/>
          <a:ext cx="3686040" cy="24544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7" name="Object 6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634000" y="633240"/>
                    <a:ext cx="3686040" cy="2454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8" name="Object 7"/>
          <p:cNvGraphicFramePr/>
          <p:nvPr/>
        </p:nvGraphicFramePr>
        <p:xfrm>
          <a:off x="5618160" y="2989440"/>
          <a:ext cx="3686040" cy="245412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49" name="Object 7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5618160" y="2989440"/>
                    <a:ext cx="3686040" cy="2454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Rectangle 6"/>
          <p:cNvSpPr/>
          <p:nvPr/>
        </p:nvSpPr>
        <p:spPr>
          <a:xfrm>
            <a:off x="152280" y="152280"/>
            <a:ext cx="121921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7"/>
          <p:cNvSpPr/>
          <p:nvPr/>
        </p:nvSpPr>
        <p:spPr>
          <a:xfrm>
            <a:off x="6157800" y="379800"/>
            <a:ext cx="1807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3-02T18:49:38Z</dcterms:created>
  <dc:creator>Osman, Mubarak</dc:creator>
  <dc:description/>
  <dc:language>en-US</dc:language>
  <cp:lastModifiedBy>td</cp:lastModifiedBy>
  <dcterms:modified xsi:type="dcterms:W3CDTF">2023-08-26T05:39:26Z</dcterms:modified>
  <cp:revision>1</cp:revision>
  <dc:subject/>
  <dc:title>PowerPoint Presentation</dc:title>
</cp:coreProperties>
</file>